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4751388" cy="4751388"/>
  <p:notesSz cx="6858000" cy="9144000"/>
  <p:custDataLst>
    <p:tags r:id="rId4"/>
  </p:custDataLst>
  <p:defaultTextStyle>
    <a:defPPr>
      <a:defRPr lang="en-US"/>
    </a:defPPr>
    <a:lvl1pPr marL="0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1pPr>
    <a:lvl2pPr marL="315823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2pPr>
    <a:lvl3pPr marL="631646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3pPr>
    <a:lvl4pPr marL="947469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4pPr>
    <a:lvl5pPr marL="1263292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5pPr>
    <a:lvl6pPr marL="1579115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6pPr>
    <a:lvl7pPr marL="1894938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7pPr>
    <a:lvl8pPr marL="2210761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8pPr>
    <a:lvl9pPr marL="2526584" algn="l" defTabSz="631646" rtl="0" eaLnBrk="1" latinLnBrk="0" hangingPunct="1">
      <a:defRPr sz="124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97" userDrawn="1">
          <p15:clr>
            <a:srgbClr val="A4A3A4"/>
          </p15:clr>
        </p15:guide>
        <p15:guide id="2" pos="149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09" autoAdjust="0"/>
    <p:restoredTop sz="94660"/>
  </p:normalViewPr>
  <p:slideViewPr>
    <p:cSldViewPr>
      <p:cViewPr>
        <p:scale>
          <a:sx n="300" d="100"/>
          <a:sy n="300" d="100"/>
        </p:scale>
        <p:origin x="-216" y="-2164"/>
      </p:cViewPr>
      <p:guideLst>
        <p:guide orient="horz" pos="1497"/>
        <p:guide pos="14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087996-38A4-4B00-A895-A17A7CDF1BA1}" type="datetimeFigureOut">
              <a:rPr lang="zh-CN" altLang="en-US" smtClean="0"/>
              <a:t>2025/8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63E612-9468-4C48-8403-1582FB0D8F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898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1pPr>
    <a:lvl2pPr marL="315823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2pPr>
    <a:lvl3pPr marL="631646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3pPr>
    <a:lvl4pPr marL="947469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4pPr>
    <a:lvl5pPr marL="1263292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5pPr>
    <a:lvl6pPr marL="1579115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6pPr>
    <a:lvl7pPr marL="1894938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7pPr>
    <a:lvl8pPr marL="2210761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8pPr>
    <a:lvl9pPr marL="2526584" algn="l" defTabSz="631646" rtl="0" eaLnBrk="1" latinLnBrk="0" hangingPunct="1">
      <a:defRPr sz="82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85950" y="1143000"/>
            <a:ext cx="30861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63E612-9468-4C48-8403-1582FB0D8F5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6206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56355" y="1476013"/>
            <a:ext cx="4038680" cy="10184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2709" y="2692458"/>
            <a:ext cx="3325972" cy="121424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935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87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80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742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67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1613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3549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548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5327" y="3053209"/>
            <a:ext cx="4038680" cy="943678"/>
          </a:xfrm>
        </p:spPr>
        <p:txBody>
          <a:bodyPr anchor="t"/>
          <a:lstStyle>
            <a:lvl1pPr algn="l">
              <a:defRPr sz="1694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5327" y="2013845"/>
            <a:ext cx="4038680" cy="1039367"/>
          </a:xfrm>
        </p:spPr>
        <p:txBody>
          <a:bodyPr anchor="b"/>
          <a:lstStyle>
            <a:lvl1pPr marL="0" indent="0">
              <a:buNone/>
              <a:defRPr sz="847">
                <a:solidFill>
                  <a:schemeClr val="tx1">
                    <a:tint val="75000"/>
                  </a:schemeClr>
                </a:solidFill>
              </a:defRPr>
            </a:lvl1pPr>
            <a:lvl2pPr marL="193565" indent="0">
              <a:buNone/>
              <a:defRPr sz="762">
                <a:solidFill>
                  <a:schemeClr val="tx1">
                    <a:tint val="75000"/>
                  </a:schemeClr>
                </a:solidFill>
              </a:defRPr>
            </a:lvl2pPr>
            <a:lvl3pPr marL="387132" indent="0">
              <a:buNone/>
              <a:defRPr sz="677">
                <a:solidFill>
                  <a:schemeClr val="tx1">
                    <a:tint val="75000"/>
                  </a:schemeClr>
                </a:solidFill>
              </a:defRPr>
            </a:lvl3pPr>
            <a:lvl4pPr marL="580695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4pPr>
            <a:lvl5pPr marL="774260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5pPr>
            <a:lvl6pPr marL="967825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6pPr>
            <a:lvl7pPr marL="1161392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7pPr>
            <a:lvl8pPr marL="1354955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8pPr>
            <a:lvl9pPr marL="1548520" indent="0">
              <a:buNone/>
              <a:defRPr sz="5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7570" y="1108659"/>
            <a:ext cx="2098530" cy="3135696"/>
          </a:xfrm>
        </p:spPr>
        <p:txBody>
          <a:bodyPr/>
          <a:lstStyle>
            <a:lvl1pPr>
              <a:defRPr sz="1184"/>
            </a:lvl1pPr>
            <a:lvl2pPr>
              <a:defRPr sz="1017"/>
            </a:lvl2pPr>
            <a:lvl3pPr>
              <a:defRPr sz="847"/>
            </a:lvl3pPr>
            <a:lvl4pPr>
              <a:defRPr sz="762"/>
            </a:lvl4pPr>
            <a:lvl5pPr>
              <a:defRPr sz="762"/>
            </a:lvl5pPr>
            <a:lvl6pPr>
              <a:defRPr sz="762"/>
            </a:lvl6pPr>
            <a:lvl7pPr>
              <a:defRPr sz="762"/>
            </a:lvl7pPr>
            <a:lvl8pPr>
              <a:defRPr sz="762"/>
            </a:lvl8pPr>
            <a:lvl9pPr>
              <a:defRPr sz="7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15290" y="1108659"/>
            <a:ext cx="2098530" cy="3135696"/>
          </a:xfrm>
        </p:spPr>
        <p:txBody>
          <a:bodyPr/>
          <a:lstStyle>
            <a:lvl1pPr>
              <a:defRPr sz="1184"/>
            </a:lvl1pPr>
            <a:lvl2pPr>
              <a:defRPr sz="1017"/>
            </a:lvl2pPr>
            <a:lvl3pPr>
              <a:defRPr sz="847"/>
            </a:lvl3pPr>
            <a:lvl4pPr>
              <a:defRPr sz="762"/>
            </a:lvl4pPr>
            <a:lvl5pPr>
              <a:defRPr sz="762"/>
            </a:lvl5pPr>
            <a:lvl6pPr>
              <a:defRPr sz="762"/>
            </a:lvl6pPr>
            <a:lvl7pPr>
              <a:defRPr sz="762"/>
            </a:lvl7pPr>
            <a:lvl8pPr>
              <a:defRPr sz="762"/>
            </a:lvl8pPr>
            <a:lvl9pPr>
              <a:defRPr sz="7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7573" y="1063565"/>
            <a:ext cx="2099355" cy="443243"/>
          </a:xfrm>
        </p:spPr>
        <p:txBody>
          <a:bodyPr anchor="b"/>
          <a:lstStyle>
            <a:lvl1pPr marL="0" indent="0">
              <a:buNone/>
              <a:defRPr sz="1017" b="1"/>
            </a:lvl1pPr>
            <a:lvl2pPr marL="193565" indent="0">
              <a:buNone/>
              <a:defRPr sz="847" b="1"/>
            </a:lvl2pPr>
            <a:lvl3pPr marL="387132" indent="0">
              <a:buNone/>
              <a:defRPr sz="762" b="1"/>
            </a:lvl3pPr>
            <a:lvl4pPr marL="580695" indent="0">
              <a:buNone/>
              <a:defRPr sz="677" b="1"/>
            </a:lvl4pPr>
            <a:lvl5pPr marL="774260" indent="0">
              <a:buNone/>
              <a:defRPr sz="677" b="1"/>
            </a:lvl5pPr>
            <a:lvl6pPr marL="967825" indent="0">
              <a:buNone/>
              <a:defRPr sz="677" b="1"/>
            </a:lvl6pPr>
            <a:lvl7pPr marL="1161392" indent="0">
              <a:buNone/>
              <a:defRPr sz="677" b="1"/>
            </a:lvl7pPr>
            <a:lvl8pPr marL="1354955" indent="0">
              <a:buNone/>
              <a:defRPr sz="677" b="1"/>
            </a:lvl8pPr>
            <a:lvl9pPr marL="1548520" indent="0">
              <a:buNone/>
              <a:defRPr sz="6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7573" y="1506807"/>
            <a:ext cx="2099355" cy="2737548"/>
          </a:xfrm>
        </p:spPr>
        <p:txBody>
          <a:bodyPr/>
          <a:lstStyle>
            <a:lvl1pPr>
              <a:defRPr sz="1017"/>
            </a:lvl1pPr>
            <a:lvl2pPr>
              <a:defRPr sz="847"/>
            </a:lvl2pPr>
            <a:lvl3pPr>
              <a:defRPr sz="762"/>
            </a:lvl3pPr>
            <a:lvl4pPr>
              <a:defRPr sz="677"/>
            </a:lvl4pPr>
            <a:lvl5pPr>
              <a:defRPr sz="677"/>
            </a:lvl5pPr>
            <a:lvl6pPr>
              <a:defRPr sz="677"/>
            </a:lvl6pPr>
            <a:lvl7pPr>
              <a:defRPr sz="677"/>
            </a:lvl7pPr>
            <a:lvl8pPr>
              <a:defRPr sz="677"/>
            </a:lvl8pPr>
            <a:lvl9pPr>
              <a:defRPr sz="6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413644" y="1063565"/>
            <a:ext cx="2100179" cy="443243"/>
          </a:xfrm>
        </p:spPr>
        <p:txBody>
          <a:bodyPr anchor="b"/>
          <a:lstStyle>
            <a:lvl1pPr marL="0" indent="0">
              <a:buNone/>
              <a:defRPr sz="1017" b="1"/>
            </a:lvl1pPr>
            <a:lvl2pPr marL="193565" indent="0">
              <a:buNone/>
              <a:defRPr sz="847" b="1"/>
            </a:lvl2pPr>
            <a:lvl3pPr marL="387132" indent="0">
              <a:buNone/>
              <a:defRPr sz="762" b="1"/>
            </a:lvl3pPr>
            <a:lvl4pPr marL="580695" indent="0">
              <a:buNone/>
              <a:defRPr sz="677" b="1"/>
            </a:lvl4pPr>
            <a:lvl5pPr marL="774260" indent="0">
              <a:buNone/>
              <a:defRPr sz="677" b="1"/>
            </a:lvl5pPr>
            <a:lvl6pPr marL="967825" indent="0">
              <a:buNone/>
              <a:defRPr sz="677" b="1"/>
            </a:lvl6pPr>
            <a:lvl7pPr marL="1161392" indent="0">
              <a:buNone/>
              <a:defRPr sz="677" b="1"/>
            </a:lvl7pPr>
            <a:lvl8pPr marL="1354955" indent="0">
              <a:buNone/>
              <a:defRPr sz="677" b="1"/>
            </a:lvl8pPr>
            <a:lvl9pPr marL="1548520" indent="0">
              <a:buNone/>
              <a:defRPr sz="6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13644" y="1506807"/>
            <a:ext cx="2100179" cy="2737548"/>
          </a:xfrm>
        </p:spPr>
        <p:txBody>
          <a:bodyPr/>
          <a:lstStyle>
            <a:lvl1pPr>
              <a:defRPr sz="1017"/>
            </a:lvl1pPr>
            <a:lvl2pPr>
              <a:defRPr sz="847"/>
            </a:lvl2pPr>
            <a:lvl3pPr>
              <a:defRPr sz="762"/>
            </a:lvl3pPr>
            <a:lvl4pPr>
              <a:defRPr sz="677"/>
            </a:lvl4pPr>
            <a:lvl5pPr>
              <a:defRPr sz="677"/>
            </a:lvl5pPr>
            <a:lvl6pPr>
              <a:defRPr sz="677"/>
            </a:lvl6pPr>
            <a:lvl7pPr>
              <a:defRPr sz="677"/>
            </a:lvl7pPr>
            <a:lvl8pPr>
              <a:defRPr sz="677"/>
            </a:lvl8pPr>
            <a:lvl9pPr>
              <a:defRPr sz="6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7573" y="190277"/>
            <a:ext cx="4276249" cy="7918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7573" y="1108659"/>
            <a:ext cx="4276249" cy="31356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7574" y="4403835"/>
            <a:ext cx="1108657" cy="2529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23391" y="4403835"/>
            <a:ext cx="1504606" cy="2529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05166" y="4403835"/>
            <a:ext cx="1108657" cy="2529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387132" rtl="0" eaLnBrk="1" latinLnBrk="0" hangingPunct="1">
        <a:spcBef>
          <a:spcPct val="0"/>
        </a:spcBef>
        <a:buNone/>
        <a:defRPr sz="18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175" indent="-145175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354" kern="1200">
          <a:solidFill>
            <a:schemeClr val="tx1"/>
          </a:solidFill>
          <a:latin typeface="+mn-lt"/>
          <a:ea typeface="+mn-ea"/>
          <a:cs typeface="+mn-cs"/>
        </a:defRPr>
      </a:lvl1pPr>
      <a:lvl2pPr marL="314544" indent="-120977" algn="l" defTabSz="387132" rtl="0" eaLnBrk="1" latinLnBrk="0" hangingPunct="1">
        <a:spcBef>
          <a:spcPct val="20000"/>
        </a:spcBef>
        <a:buFont typeface="Arial" panose="020B0604020202020204" pitchFamily="34" charset="0"/>
        <a:buChar char="–"/>
        <a:defRPr sz="1184" kern="1200">
          <a:solidFill>
            <a:schemeClr val="tx1"/>
          </a:solidFill>
          <a:latin typeface="+mn-lt"/>
          <a:ea typeface="+mn-ea"/>
          <a:cs typeface="+mn-cs"/>
        </a:defRPr>
      </a:lvl2pPr>
      <a:lvl3pPr marL="483914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017" kern="1200">
          <a:solidFill>
            <a:schemeClr val="tx1"/>
          </a:solidFill>
          <a:latin typeface="+mn-lt"/>
          <a:ea typeface="+mn-ea"/>
          <a:cs typeface="+mn-cs"/>
        </a:defRPr>
      </a:lvl3pPr>
      <a:lvl4pPr marL="677478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–"/>
        <a:defRPr sz="847" kern="1200">
          <a:solidFill>
            <a:schemeClr val="tx1"/>
          </a:solidFill>
          <a:latin typeface="+mn-lt"/>
          <a:ea typeface="+mn-ea"/>
          <a:cs typeface="+mn-cs"/>
        </a:defRPr>
      </a:lvl4pPr>
      <a:lvl5pPr marL="871041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»"/>
        <a:defRPr sz="847" kern="1200">
          <a:solidFill>
            <a:schemeClr val="tx1"/>
          </a:solidFill>
          <a:latin typeface="+mn-lt"/>
          <a:ea typeface="+mn-ea"/>
          <a:cs typeface="+mn-cs"/>
        </a:defRPr>
      </a:lvl5pPr>
      <a:lvl6pPr marL="1064609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847" kern="1200">
          <a:solidFill>
            <a:schemeClr val="tx1"/>
          </a:solidFill>
          <a:latin typeface="+mn-lt"/>
          <a:ea typeface="+mn-ea"/>
          <a:cs typeface="+mn-cs"/>
        </a:defRPr>
      </a:lvl6pPr>
      <a:lvl7pPr marL="1258173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847" kern="1200">
          <a:solidFill>
            <a:schemeClr val="tx1"/>
          </a:solidFill>
          <a:latin typeface="+mn-lt"/>
          <a:ea typeface="+mn-ea"/>
          <a:cs typeface="+mn-cs"/>
        </a:defRPr>
      </a:lvl7pPr>
      <a:lvl8pPr marL="1451738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847" kern="1200">
          <a:solidFill>
            <a:schemeClr val="tx1"/>
          </a:solidFill>
          <a:latin typeface="+mn-lt"/>
          <a:ea typeface="+mn-ea"/>
          <a:cs typeface="+mn-cs"/>
        </a:defRPr>
      </a:lvl8pPr>
      <a:lvl9pPr marL="1645303" indent="-96783" algn="l" defTabSz="387132" rtl="0" eaLnBrk="1" latinLnBrk="0" hangingPunct="1">
        <a:spcBef>
          <a:spcPct val="20000"/>
        </a:spcBef>
        <a:buFont typeface="Arial" panose="020B0604020202020204" pitchFamily="34" charset="0"/>
        <a:buChar char="•"/>
        <a:defRPr sz="8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1pPr>
      <a:lvl2pPr marL="193565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2pPr>
      <a:lvl3pPr marL="387132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3pPr>
      <a:lvl4pPr marL="580695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4pPr>
      <a:lvl5pPr marL="774260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5pPr>
      <a:lvl6pPr marL="967825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6pPr>
      <a:lvl7pPr marL="1161392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7pPr>
      <a:lvl8pPr marL="1354955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8pPr>
      <a:lvl9pPr marL="1548520" algn="l" defTabSz="387132" rtl="0" eaLnBrk="1" latinLnBrk="0" hangingPunct="1">
        <a:defRPr sz="7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c3"/>
          <p:cNvSpPr/>
          <p:nvPr/>
        </p:nvSpPr>
        <p:spPr>
          <a:xfrm>
            <a:off x="30918" y="978807"/>
            <a:ext cx="4720470" cy="2793778"/>
          </a:xfrm>
          <a:prstGeom prst="rect">
            <a:avLst/>
          </a:prstGeom>
          <a:solidFill>
            <a:srgbClr val="FFFFFF">
              <a:alpha val="100000"/>
            </a:srgbClr>
          </a:solidFill>
          <a:ln w="9525" cap="rnd">
            <a:solidFill>
              <a:srgbClr val="FFFFFF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84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c4"/>
          <p:cNvSpPr/>
          <p:nvPr/>
        </p:nvSpPr>
        <p:spPr>
          <a:xfrm>
            <a:off x="4164922" y="3033472"/>
            <a:ext cx="61527" cy="70800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c5"/>
          <p:cNvSpPr/>
          <p:nvPr/>
        </p:nvSpPr>
        <p:spPr>
          <a:xfrm>
            <a:off x="3754732" y="3005153"/>
            <a:ext cx="61527" cy="99120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c6"/>
          <p:cNvSpPr/>
          <p:nvPr/>
        </p:nvSpPr>
        <p:spPr>
          <a:xfrm>
            <a:off x="1293586" y="2155549"/>
            <a:ext cx="61527" cy="948723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c7"/>
          <p:cNvSpPr/>
          <p:nvPr/>
        </p:nvSpPr>
        <p:spPr>
          <a:xfrm>
            <a:off x="3344542" y="2948511"/>
            <a:ext cx="61527" cy="155760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c8"/>
          <p:cNvSpPr/>
          <p:nvPr/>
        </p:nvSpPr>
        <p:spPr>
          <a:xfrm>
            <a:off x="2524160" y="2736112"/>
            <a:ext cx="61527" cy="368160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c9"/>
          <p:cNvSpPr/>
          <p:nvPr/>
        </p:nvSpPr>
        <p:spPr>
          <a:xfrm>
            <a:off x="2934350" y="2778591"/>
            <a:ext cx="61527" cy="325681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c10"/>
          <p:cNvSpPr/>
          <p:nvPr/>
        </p:nvSpPr>
        <p:spPr>
          <a:xfrm>
            <a:off x="2113968" y="2594511"/>
            <a:ext cx="61527" cy="509761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c11"/>
          <p:cNvSpPr/>
          <p:nvPr/>
        </p:nvSpPr>
        <p:spPr>
          <a:xfrm>
            <a:off x="1703778" y="2566191"/>
            <a:ext cx="61527" cy="538082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c12"/>
          <p:cNvSpPr/>
          <p:nvPr/>
        </p:nvSpPr>
        <p:spPr>
          <a:xfrm>
            <a:off x="883396" y="1504188"/>
            <a:ext cx="61527" cy="1600084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c13"/>
          <p:cNvSpPr/>
          <p:nvPr/>
        </p:nvSpPr>
        <p:spPr>
          <a:xfrm>
            <a:off x="473204" y="1263468"/>
            <a:ext cx="61527" cy="1840804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c14"/>
          <p:cNvSpPr/>
          <p:nvPr/>
        </p:nvSpPr>
        <p:spPr>
          <a:xfrm>
            <a:off x="4246962" y="3061791"/>
            <a:ext cx="61527" cy="42479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c15"/>
          <p:cNvSpPr/>
          <p:nvPr/>
        </p:nvSpPr>
        <p:spPr>
          <a:xfrm>
            <a:off x="3836770" y="3090112"/>
            <a:ext cx="61527" cy="1416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c16"/>
          <p:cNvSpPr/>
          <p:nvPr/>
        </p:nvSpPr>
        <p:spPr>
          <a:xfrm>
            <a:off x="1375625" y="2438749"/>
            <a:ext cx="61527" cy="665521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c17"/>
          <p:cNvSpPr/>
          <p:nvPr/>
        </p:nvSpPr>
        <p:spPr>
          <a:xfrm>
            <a:off x="3426580" y="3075951"/>
            <a:ext cx="61527" cy="28319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c18"/>
          <p:cNvSpPr/>
          <p:nvPr/>
        </p:nvSpPr>
        <p:spPr>
          <a:xfrm>
            <a:off x="2606197" y="2948511"/>
            <a:ext cx="61527" cy="15576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c19"/>
          <p:cNvSpPr/>
          <p:nvPr/>
        </p:nvSpPr>
        <p:spPr>
          <a:xfrm>
            <a:off x="3016387" y="2849391"/>
            <a:ext cx="61527" cy="25488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c20"/>
          <p:cNvSpPr/>
          <p:nvPr/>
        </p:nvSpPr>
        <p:spPr>
          <a:xfrm>
            <a:off x="2196007" y="2835231"/>
            <a:ext cx="61527" cy="26904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c21"/>
          <p:cNvSpPr/>
          <p:nvPr/>
        </p:nvSpPr>
        <p:spPr>
          <a:xfrm>
            <a:off x="1785815" y="2877710"/>
            <a:ext cx="61527" cy="226561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c22"/>
          <p:cNvSpPr/>
          <p:nvPr/>
        </p:nvSpPr>
        <p:spPr>
          <a:xfrm>
            <a:off x="965433" y="2325472"/>
            <a:ext cx="61527" cy="77880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c23"/>
          <p:cNvSpPr/>
          <p:nvPr/>
        </p:nvSpPr>
        <p:spPr>
          <a:xfrm>
            <a:off x="555243" y="1560830"/>
            <a:ext cx="61527" cy="1543443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c24"/>
          <p:cNvSpPr/>
          <p:nvPr/>
        </p:nvSpPr>
        <p:spPr>
          <a:xfrm>
            <a:off x="4328999" y="3047632"/>
            <a:ext cx="61527" cy="56641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c25"/>
          <p:cNvSpPr/>
          <p:nvPr/>
        </p:nvSpPr>
        <p:spPr>
          <a:xfrm>
            <a:off x="3918807" y="3090112"/>
            <a:ext cx="61527" cy="14160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c26"/>
          <p:cNvSpPr/>
          <p:nvPr/>
        </p:nvSpPr>
        <p:spPr>
          <a:xfrm>
            <a:off x="1457662" y="2113070"/>
            <a:ext cx="61527" cy="991202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c27"/>
          <p:cNvSpPr/>
          <p:nvPr/>
        </p:nvSpPr>
        <p:spPr>
          <a:xfrm>
            <a:off x="3508617" y="3019313"/>
            <a:ext cx="61527" cy="84960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c28"/>
          <p:cNvSpPr/>
          <p:nvPr/>
        </p:nvSpPr>
        <p:spPr>
          <a:xfrm>
            <a:off x="2688235" y="2877710"/>
            <a:ext cx="61527" cy="226561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c29"/>
          <p:cNvSpPr/>
          <p:nvPr/>
        </p:nvSpPr>
        <p:spPr>
          <a:xfrm>
            <a:off x="3098427" y="2778591"/>
            <a:ext cx="61527" cy="325681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c30"/>
          <p:cNvSpPr/>
          <p:nvPr/>
        </p:nvSpPr>
        <p:spPr>
          <a:xfrm>
            <a:off x="2278045" y="2721951"/>
            <a:ext cx="61527" cy="382319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c31"/>
          <p:cNvSpPr/>
          <p:nvPr/>
        </p:nvSpPr>
        <p:spPr>
          <a:xfrm>
            <a:off x="1867853" y="2891871"/>
            <a:ext cx="61527" cy="212399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c32"/>
          <p:cNvSpPr/>
          <p:nvPr/>
        </p:nvSpPr>
        <p:spPr>
          <a:xfrm>
            <a:off x="1047472" y="2325472"/>
            <a:ext cx="61527" cy="778800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c33"/>
          <p:cNvSpPr/>
          <p:nvPr/>
        </p:nvSpPr>
        <p:spPr>
          <a:xfrm>
            <a:off x="637280" y="1305947"/>
            <a:ext cx="61527" cy="1798323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c34"/>
          <p:cNvSpPr/>
          <p:nvPr/>
        </p:nvSpPr>
        <p:spPr>
          <a:xfrm>
            <a:off x="4411038" y="3075951"/>
            <a:ext cx="61527" cy="28319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c35"/>
          <p:cNvSpPr/>
          <p:nvPr/>
        </p:nvSpPr>
        <p:spPr>
          <a:xfrm>
            <a:off x="4000846" y="3104272"/>
            <a:ext cx="61527" cy="0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c36"/>
          <p:cNvSpPr/>
          <p:nvPr/>
        </p:nvSpPr>
        <p:spPr>
          <a:xfrm>
            <a:off x="1539700" y="2070590"/>
            <a:ext cx="61527" cy="1033683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c37"/>
          <p:cNvSpPr/>
          <p:nvPr/>
        </p:nvSpPr>
        <p:spPr>
          <a:xfrm>
            <a:off x="3590656" y="3019313"/>
            <a:ext cx="61527" cy="84960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c38"/>
          <p:cNvSpPr/>
          <p:nvPr/>
        </p:nvSpPr>
        <p:spPr>
          <a:xfrm>
            <a:off x="2770274" y="2906032"/>
            <a:ext cx="61527" cy="198240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c39"/>
          <p:cNvSpPr/>
          <p:nvPr/>
        </p:nvSpPr>
        <p:spPr>
          <a:xfrm>
            <a:off x="3180464" y="2920192"/>
            <a:ext cx="61527" cy="184080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c40"/>
          <p:cNvSpPr/>
          <p:nvPr/>
        </p:nvSpPr>
        <p:spPr>
          <a:xfrm>
            <a:off x="2360082" y="2792751"/>
            <a:ext cx="61527" cy="311521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c41"/>
          <p:cNvSpPr/>
          <p:nvPr/>
        </p:nvSpPr>
        <p:spPr>
          <a:xfrm>
            <a:off x="1949892" y="2806912"/>
            <a:ext cx="61527" cy="297361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c42"/>
          <p:cNvSpPr/>
          <p:nvPr/>
        </p:nvSpPr>
        <p:spPr>
          <a:xfrm>
            <a:off x="1129510" y="2212191"/>
            <a:ext cx="61527" cy="892082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c43"/>
          <p:cNvSpPr/>
          <p:nvPr/>
        </p:nvSpPr>
        <p:spPr>
          <a:xfrm>
            <a:off x="719318" y="1475869"/>
            <a:ext cx="61527" cy="1628403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x44"/>
          <p:cNvSpPr/>
          <p:nvPr/>
        </p:nvSpPr>
        <p:spPr>
          <a:xfrm>
            <a:off x="4185961" y="2993867"/>
            <a:ext cx="19452" cy="2643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46" name="tx45"/>
          <p:cNvSpPr/>
          <p:nvPr/>
        </p:nvSpPr>
        <p:spPr>
          <a:xfrm>
            <a:off x="3775769" y="2965978"/>
            <a:ext cx="19452" cy="26002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47" name="tx46"/>
          <p:cNvSpPr/>
          <p:nvPr/>
        </p:nvSpPr>
        <p:spPr>
          <a:xfrm>
            <a:off x="1304899" y="2115478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</a:p>
        </p:txBody>
      </p:sp>
      <p:sp>
        <p:nvSpPr>
          <p:cNvPr id="48" name="tx47"/>
          <p:cNvSpPr/>
          <p:nvPr/>
        </p:nvSpPr>
        <p:spPr>
          <a:xfrm>
            <a:off x="3355853" y="2908890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49" name="tx48"/>
          <p:cNvSpPr/>
          <p:nvPr/>
        </p:nvSpPr>
        <p:spPr>
          <a:xfrm>
            <a:off x="2535471" y="2696040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50" name="tx49"/>
          <p:cNvSpPr/>
          <p:nvPr/>
        </p:nvSpPr>
        <p:spPr>
          <a:xfrm>
            <a:off x="2945663" y="2738502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51" name="tx50"/>
          <p:cNvSpPr/>
          <p:nvPr/>
        </p:nvSpPr>
        <p:spPr>
          <a:xfrm>
            <a:off x="2125281" y="2554423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</a:p>
        </p:txBody>
      </p:sp>
      <p:sp>
        <p:nvSpPr>
          <p:cNvPr id="52" name="tx51"/>
          <p:cNvSpPr/>
          <p:nvPr/>
        </p:nvSpPr>
        <p:spPr>
          <a:xfrm>
            <a:off x="1715089" y="2526101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</a:p>
        </p:txBody>
      </p:sp>
      <p:sp>
        <p:nvSpPr>
          <p:cNvPr id="53" name="tx52"/>
          <p:cNvSpPr/>
          <p:nvPr/>
        </p:nvSpPr>
        <p:spPr>
          <a:xfrm>
            <a:off x="884983" y="1464099"/>
            <a:ext cx="58357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3</a:t>
            </a:r>
          </a:p>
        </p:txBody>
      </p:sp>
      <p:sp>
        <p:nvSpPr>
          <p:cNvPr id="54" name="tx53"/>
          <p:cNvSpPr/>
          <p:nvPr/>
        </p:nvSpPr>
        <p:spPr>
          <a:xfrm>
            <a:off x="474791" y="1223379"/>
            <a:ext cx="58357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</p:txBody>
      </p:sp>
      <p:sp>
        <p:nvSpPr>
          <p:cNvPr id="55" name="tx54"/>
          <p:cNvSpPr/>
          <p:nvPr/>
        </p:nvSpPr>
        <p:spPr>
          <a:xfrm>
            <a:off x="4268000" y="3021702"/>
            <a:ext cx="19452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56" name="tx55"/>
          <p:cNvSpPr/>
          <p:nvPr/>
        </p:nvSpPr>
        <p:spPr>
          <a:xfrm>
            <a:off x="3857808" y="3050491"/>
            <a:ext cx="19452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7" name="tx56"/>
          <p:cNvSpPr/>
          <p:nvPr/>
        </p:nvSpPr>
        <p:spPr>
          <a:xfrm>
            <a:off x="1386938" y="2399236"/>
            <a:ext cx="38905" cy="2634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</a:p>
        </p:txBody>
      </p:sp>
      <p:sp>
        <p:nvSpPr>
          <p:cNvPr id="58" name="tx57"/>
          <p:cNvSpPr/>
          <p:nvPr/>
        </p:nvSpPr>
        <p:spPr>
          <a:xfrm>
            <a:off x="3447618" y="3036332"/>
            <a:ext cx="19452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59" name="tx58"/>
          <p:cNvSpPr/>
          <p:nvPr/>
        </p:nvSpPr>
        <p:spPr>
          <a:xfrm>
            <a:off x="2617509" y="2908890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60" name="tx59"/>
          <p:cNvSpPr/>
          <p:nvPr/>
        </p:nvSpPr>
        <p:spPr>
          <a:xfrm>
            <a:off x="3027701" y="2809320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61" name="tx60"/>
          <p:cNvSpPr/>
          <p:nvPr/>
        </p:nvSpPr>
        <p:spPr>
          <a:xfrm>
            <a:off x="2207319" y="2795160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  <p:sp>
        <p:nvSpPr>
          <p:cNvPr id="62" name="tx61"/>
          <p:cNvSpPr/>
          <p:nvPr/>
        </p:nvSpPr>
        <p:spPr>
          <a:xfrm>
            <a:off x="1797128" y="2837641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63" name="tx62"/>
          <p:cNvSpPr/>
          <p:nvPr/>
        </p:nvSpPr>
        <p:spPr>
          <a:xfrm>
            <a:off x="976746" y="2285865"/>
            <a:ext cx="38905" cy="2643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sp>
        <p:nvSpPr>
          <p:cNvPr id="64" name="tx63"/>
          <p:cNvSpPr/>
          <p:nvPr/>
        </p:nvSpPr>
        <p:spPr>
          <a:xfrm>
            <a:off x="556830" y="1520759"/>
            <a:ext cx="58357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9</a:t>
            </a:r>
          </a:p>
        </p:txBody>
      </p:sp>
      <p:sp>
        <p:nvSpPr>
          <p:cNvPr id="65" name="tx64"/>
          <p:cNvSpPr/>
          <p:nvPr/>
        </p:nvSpPr>
        <p:spPr>
          <a:xfrm>
            <a:off x="4350037" y="3008117"/>
            <a:ext cx="19452" cy="2634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66" name="tx65"/>
          <p:cNvSpPr/>
          <p:nvPr/>
        </p:nvSpPr>
        <p:spPr>
          <a:xfrm>
            <a:off x="3939847" y="3050491"/>
            <a:ext cx="19452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67" name="tx66"/>
          <p:cNvSpPr/>
          <p:nvPr/>
        </p:nvSpPr>
        <p:spPr>
          <a:xfrm>
            <a:off x="1468976" y="2073000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</p:txBody>
      </p:sp>
      <p:sp>
        <p:nvSpPr>
          <p:cNvPr id="68" name="tx67"/>
          <p:cNvSpPr/>
          <p:nvPr/>
        </p:nvSpPr>
        <p:spPr>
          <a:xfrm>
            <a:off x="3529655" y="2979240"/>
            <a:ext cx="19452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69" name="tx68"/>
          <p:cNvSpPr/>
          <p:nvPr/>
        </p:nvSpPr>
        <p:spPr>
          <a:xfrm>
            <a:off x="2699548" y="2837641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70" name="tx69"/>
          <p:cNvSpPr/>
          <p:nvPr/>
        </p:nvSpPr>
        <p:spPr>
          <a:xfrm>
            <a:off x="3109740" y="2738502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71" name="tx70"/>
          <p:cNvSpPr/>
          <p:nvPr/>
        </p:nvSpPr>
        <p:spPr>
          <a:xfrm>
            <a:off x="2289358" y="2682330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</a:p>
        </p:txBody>
      </p:sp>
      <p:sp>
        <p:nvSpPr>
          <p:cNvPr id="72" name="tx71"/>
          <p:cNvSpPr/>
          <p:nvPr/>
        </p:nvSpPr>
        <p:spPr>
          <a:xfrm>
            <a:off x="1879166" y="2851801"/>
            <a:ext cx="38905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73" name="tx72"/>
          <p:cNvSpPr/>
          <p:nvPr/>
        </p:nvSpPr>
        <p:spPr>
          <a:xfrm>
            <a:off x="1058784" y="2285865"/>
            <a:ext cx="38905" cy="2643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sp>
        <p:nvSpPr>
          <p:cNvPr id="74" name="tx73"/>
          <p:cNvSpPr/>
          <p:nvPr/>
        </p:nvSpPr>
        <p:spPr>
          <a:xfrm>
            <a:off x="638867" y="1266328"/>
            <a:ext cx="58357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7</a:t>
            </a:r>
          </a:p>
        </p:txBody>
      </p:sp>
      <p:sp>
        <p:nvSpPr>
          <p:cNvPr id="75" name="tx74"/>
          <p:cNvSpPr/>
          <p:nvPr/>
        </p:nvSpPr>
        <p:spPr>
          <a:xfrm>
            <a:off x="4432075" y="3036332"/>
            <a:ext cx="19452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76" name="tx75"/>
          <p:cNvSpPr/>
          <p:nvPr/>
        </p:nvSpPr>
        <p:spPr>
          <a:xfrm>
            <a:off x="4021885" y="3064202"/>
            <a:ext cx="19452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77" name="tx76"/>
          <p:cNvSpPr/>
          <p:nvPr/>
        </p:nvSpPr>
        <p:spPr>
          <a:xfrm>
            <a:off x="1551013" y="2030500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</a:p>
        </p:txBody>
      </p:sp>
      <p:sp>
        <p:nvSpPr>
          <p:cNvPr id="78" name="tx77"/>
          <p:cNvSpPr/>
          <p:nvPr/>
        </p:nvSpPr>
        <p:spPr>
          <a:xfrm>
            <a:off x="3611693" y="2979240"/>
            <a:ext cx="19452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79" name="tx78"/>
          <p:cNvSpPr/>
          <p:nvPr/>
        </p:nvSpPr>
        <p:spPr>
          <a:xfrm>
            <a:off x="2781587" y="2866409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80" name="tx79"/>
          <p:cNvSpPr/>
          <p:nvPr/>
        </p:nvSpPr>
        <p:spPr>
          <a:xfrm>
            <a:off x="3191777" y="2880103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81" name="tx80"/>
          <p:cNvSpPr/>
          <p:nvPr/>
        </p:nvSpPr>
        <p:spPr>
          <a:xfrm>
            <a:off x="2371395" y="2753130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82" name="tx81"/>
          <p:cNvSpPr/>
          <p:nvPr/>
        </p:nvSpPr>
        <p:spPr>
          <a:xfrm>
            <a:off x="1961205" y="2767290"/>
            <a:ext cx="38905" cy="2645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83" name="tx82"/>
          <p:cNvSpPr/>
          <p:nvPr/>
        </p:nvSpPr>
        <p:spPr>
          <a:xfrm>
            <a:off x="1140823" y="2172101"/>
            <a:ext cx="38905" cy="26918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</p:txBody>
      </p:sp>
      <p:sp>
        <p:nvSpPr>
          <p:cNvPr id="84" name="tx83"/>
          <p:cNvSpPr/>
          <p:nvPr/>
        </p:nvSpPr>
        <p:spPr>
          <a:xfrm>
            <a:off x="720905" y="1435797"/>
            <a:ext cx="58357" cy="2689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362"/>
              </a:lnSpc>
            </a:pPr>
            <a:r>
              <a:rPr sz="362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5</a:t>
            </a:r>
          </a:p>
        </p:txBody>
      </p:sp>
      <p:sp>
        <p:nvSpPr>
          <p:cNvPr id="85" name="pl84"/>
          <p:cNvSpPr/>
          <p:nvPr/>
        </p:nvSpPr>
        <p:spPr>
          <a:xfrm>
            <a:off x="216834" y="1171428"/>
            <a:ext cx="0" cy="2024884"/>
          </a:xfrm>
          <a:custGeom>
            <a:avLst/>
            <a:gdLst/>
            <a:ahLst/>
            <a:cxnLst/>
            <a:rect l="0" t="0" r="0" b="0"/>
            <a:pathLst>
              <a:path h="5964680">
                <a:moveTo>
                  <a:pt x="0" y="5964680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x85"/>
          <p:cNvSpPr/>
          <p:nvPr/>
        </p:nvSpPr>
        <p:spPr>
          <a:xfrm>
            <a:off x="157278" y="3084971"/>
            <a:ext cx="27346" cy="3781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507"/>
              </a:lnSpc>
            </a:pPr>
            <a:r>
              <a:rPr sz="507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7" name="tx86"/>
          <p:cNvSpPr/>
          <p:nvPr/>
        </p:nvSpPr>
        <p:spPr>
          <a:xfrm>
            <a:off x="129930" y="2376969"/>
            <a:ext cx="54694" cy="3781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507"/>
              </a:lnSpc>
            </a:pPr>
            <a:r>
              <a:rPr sz="507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88" name="tx87"/>
          <p:cNvSpPr/>
          <p:nvPr/>
        </p:nvSpPr>
        <p:spPr>
          <a:xfrm>
            <a:off x="102582" y="1668969"/>
            <a:ext cx="82041" cy="3781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507"/>
              </a:lnSpc>
            </a:pPr>
            <a:r>
              <a:rPr sz="507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89" name="pl88"/>
          <p:cNvSpPr/>
          <p:nvPr/>
        </p:nvSpPr>
        <p:spPr>
          <a:xfrm>
            <a:off x="193606" y="3104272"/>
            <a:ext cx="2322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pl89"/>
          <p:cNvSpPr/>
          <p:nvPr/>
        </p:nvSpPr>
        <p:spPr>
          <a:xfrm>
            <a:off x="193606" y="2396270"/>
            <a:ext cx="2322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pl90"/>
          <p:cNvSpPr/>
          <p:nvPr/>
        </p:nvSpPr>
        <p:spPr>
          <a:xfrm>
            <a:off x="193606" y="1688268"/>
            <a:ext cx="23229" cy="0"/>
          </a:xfrm>
          <a:custGeom>
            <a:avLst/>
            <a:gdLst/>
            <a:ahLst/>
            <a:cxnLst/>
            <a:rect l="0" t="0" r="0" b="0"/>
            <a:pathLst>
              <a:path w="71999">
                <a:moveTo>
                  <a:pt x="0" y="0"/>
                </a:moveTo>
                <a:lnTo>
                  <a:pt x="71999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pl91"/>
          <p:cNvSpPr/>
          <p:nvPr/>
        </p:nvSpPr>
        <p:spPr>
          <a:xfrm>
            <a:off x="216835" y="3196312"/>
            <a:ext cx="4512099" cy="0"/>
          </a:xfrm>
          <a:custGeom>
            <a:avLst/>
            <a:gdLst/>
            <a:ahLst/>
            <a:cxnLst/>
            <a:rect l="0" t="0" r="0" b="0"/>
            <a:pathLst>
              <a:path w="13984586">
                <a:moveTo>
                  <a:pt x="0" y="0"/>
                </a:moveTo>
                <a:lnTo>
                  <a:pt x="13984586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pl92"/>
          <p:cNvSpPr/>
          <p:nvPr/>
        </p:nvSpPr>
        <p:spPr>
          <a:xfrm>
            <a:off x="627026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pl93"/>
          <p:cNvSpPr/>
          <p:nvPr/>
        </p:nvSpPr>
        <p:spPr>
          <a:xfrm>
            <a:off x="1037216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pl94"/>
          <p:cNvSpPr/>
          <p:nvPr/>
        </p:nvSpPr>
        <p:spPr>
          <a:xfrm>
            <a:off x="1447408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pl95"/>
          <p:cNvSpPr/>
          <p:nvPr/>
        </p:nvSpPr>
        <p:spPr>
          <a:xfrm>
            <a:off x="1857598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pl96"/>
          <p:cNvSpPr/>
          <p:nvPr/>
        </p:nvSpPr>
        <p:spPr>
          <a:xfrm>
            <a:off x="2267789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pl97"/>
          <p:cNvSpPr/>
          <p:nvPr/>
        </p:nvSpPr>
        <p:spPr>
          <a:xfrm>
            <a:off x="2677979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pl98"/>
          <p:cNvSpPr/>
          <p:nvPr/>
        </p:nvSpPr>
        <p:spPr>
          <a:xfrm>
            <a:off x="3088171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pl99"/>
          <p:cNvSpPr/>
          <p:nvPr/>
        </p:nvSpPr>
        <p:spPr>
          <a:xfrm>
            <a:off x="3498361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pl100"/>
          <p:cNvSpPr/>
          <p:nvPr/>
        </p:nvSpPr>
        <p:spPr>
          <a:xfrm>
            <a:off x="3908553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pl101"/>
          <p:cNvSpPr/>
          <p:nvPr/>
        </p:nvSpPr>
        <p:spPr>
          <a:xfrm>
            <a:off x="4318743" y="3196312"/>
            <a:ext cx="0" cy="24442"/>
          </a:xfrm>
          <a:custGeom>
            <a:avLst/>
            <a:gdLst/>
            <a:ahLst/>
            <a:cxnLst/>
            <a:rect l="0" t="0" r="0" b="0"/>
            <a:pathLst>
              <a:path h="71999">
                <a:moveTo>
                  <a:pt x="0" y="71999"/>
                </a:moveTo>
                <a:lnTo>
                  <a:pt x="0" y="0"/>
                </a:lnTo>
              </a:path>
            </a:pathLst>
          </a:custGeom>
          <a:ln w="13550" cap="flat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x102"/>
          <p:cNvSpPr/>
          <p:nvPr/>
        </p:nvSpPr>
        <p:spPr>
          <a:xfrm rot="18900000">
            <a:off x="269000" y="3377673"/>
            <a:ext cx="428229" cy="394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used other protections</a:t>
            </a:r>
          </a:p>
        </p:txBody>
      </p:sp>
      <p:sp>
        <p:nvSpPr>
          <p:cNvPr id="104" name="tx103"/>
          <p:cNvSpPr/>
          <p:nvPr/>
        </p:nvSpPr>
        <p:spPr>
          <a:xfrm rot="18900000">
            <a:off x="422479" y="3356312"/>
            <a:ext cx="284673" cy="4046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.g., condoms)</a:t>
            </a:r>
          </a:p>
        </p:txBody>
      </p:sp>
      <p:sp>
        <p:nvSpPr>
          <p:cNvPr id="105" name="tx104"/>
          <p:cNvSpPr/>
          <p:nvPr/>
        </p:nvSpPr>
        <p:spPr>
          <a:xfrm rot="18900000">
            <a:off x="729429" y="3354745"/>
            <a:ext cx="368967" cy="4046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 dirty="0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forgot to take PrEP</a:t>
            </a:r>
          </a:p>
        </p:txBody>
      </p:sp>
      <p:sp>
        <p:nvSpPr>
          <p:cNvPr id="106" name="tx105"/>
          <p:cNvSpPr/>
          <p:nvPr/>
        </p:nvSpPr>
        <p:spPr>
          <a:xfrm rot="18900000">
            <a:off x="1190399" y="3333142"/>
            <a:ext cx="309682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trust my partner</a:t>
            </a:r>
          </a:p>
        </p:txBody>
      </p:sp>
      <p:sp>
        <p:nvSpPr>
          <p:cNvPr id="107" name="tx106"/>
          <p:cNvSpPr/>
          <p:nvPr/>
        </p:nvSpPr>
        <p:spPr>
          <a:xfrm rot="18900000">
            <a:off x="1422437" y="3418826"/>
            <a:ext cx="521568" cy="3189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 was inconvenient for me to</a:t>
            </a:r>
          </a:p>
        </p:txBody>
      </p:sp>
      <p:sp>
        <p:nvSpPr>
          <p:cNvPr id="108" name="tx107"/>
          <p:cNvSpPr/>
          <p:nvPr/>
        </p:nvSpPr>
        <p:spPr>
          <a:xfrm rot="18900000">
            <a:off x="1741634" y="3326802"/>
            <a:ext cx="184472" cy="3136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ke PrEP</a:t>
            </a:r>
          </a:p>
        </p:txBody>
      </p:sp>
      <p:sp>
        <p:nvSpPr>
          <p:cNvPr id="109" name="tx108"/>
          <p:cNvSpPr/>
          <p:nvPr/>
        </p:nvSpPr>
        <p:spPr>
          <a:xfrm rot="18900000">
            <a:off x="1876717" y="3392074"/>
            <a:ext cx="466946" cy="394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experience adverse side</a:t>
            </a:r>
          </a:p>
        </p:txBody>
      </p:sp>
      <p:sp>
        <p:nvSpPr>
          <p:cNvPr id="110" name="tx109"/>
          <p:cNvSpPr/>
          <p:nvPr/>
        </p:nvSpPr>
        <p:spPr>
          <a:xfrm rot="18900000">
            <a:off x="2206076" y="3302633"/>
            <a:ext cx="120708" cy="3189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</a:p>
        </p:txBody>
      </p:sp>
      <p:sp>
        <p:nvSpPr>
          <p:cNvPr id="111" name="tx110"/>
          <p:cNvSpPr/>
          <p:nvPr/>
        </p:nvSpPr>
        <p:spPr>
          <a:xfrm rot="18900000">
            <a:off x="2583031" y="3270513"/>
            <a:ext cx="122969" cy="31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s</a:t>
            </a:r>
          </a:p>
        </p:txBody>
      </p:sp>
      <p:sp>
        <p:nvSpPr>
          <p:cNvPr id="112" name="tx111"/>
          <p:cNvSpPr/>
          <p:nvPr/>
        </p:nvSpPr>
        <p:spPr>
          <a:xfrm rot="18900000">
            <a:off x="2632882" y="3428125"/>
            <a:ext cx="545358" cy="31367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don't have access to PrEP in</a:t>
            </a:r>
          </a:p>
        </p:txBody>
      </p:sp>
      <p:sp>
        <p:nvSpPr>
          <p:cNvPr id="113" name="tx112"/>
          <p:cNvSpPr/>
          <p:nvPr/>
        </p:nvSpPr>
        <p:spPr>
          <a:xfrm rot="18900000">
            <a:off x="2907146" y="3346589"/>
            <a:ext cx="257323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mely manner</a:t>
            </a:r>
          </a:p>
        </p:txBody>
      </p:sp>
      <p:sp>
        <p:nvSpPr>
          <p:cNvPr id="114" name="tx113"/>
          <p:cNvSpPr/>
          <p:nvPr/>
        </p:nvSpPr>
        <p:spPr>
          <a:xfrm rot="18900000">
            <a:off x="3138269" y="3378067"/>
            <a:ext cx="430453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have privacy concerns</a:t>
            </a:r>
          </a:p>
        </p:txBody>
      </p:sp>
      <p:sp>
        <p:nvSpPr>
          <p:cNvPr id="115" name="tx114"/>
          <p:cNvSpPr/>
          <p:nvPr/>
        </p:nvSpPr>
        <p:spPr>
          <a:xfrm rot="18900000">
            <a:off x="3483463" y="3406396"/>
            <a:ext cx="506602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don't know the correct way</a:t>
            </a:r>
          </a:p>
        </p:txBody>
      </p:sp>
      <p:sp>
        <p:nvSpPr>
          <p:cNvPr id="116" name="tx115"/>
          <p:cNvSpPr/>
          <p:nvPr/>
        </p:nvSpPr>
        <p:spPr>
          <a:xfrm rot="18900000">
            <a:off x="3723425" y="3347850"/>
            <a:ext cx="261924" cy="4046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taking PrEP</a:t>
            </a:r>
          </a:p>
        </p:txBody>
      </p:sp>
      <p:sp>
        <p:nvSpPr>
          <p:cNvPr id="117" name="tx116"/>
          <p:cNvSpPr/>
          <p:nvPr/>
        </p:nvSpPr>
        <p:spPr>
          <a:xfrm rot="18900000">
            <a:off x="4003449" y="3358544"/>
            <a:ext cx="377970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 worry that PrEP will</a:t>
            </a:r>
          </a:p>
        </p:txBody>
      </p:sp>
      <p:sp>
        <p:nvSpPr>
          <p:cNvPr id="118" name="tx117"/>
          <p:cNvSpPr/>
          <p:nvPr/>
        </p:nvSpPr>
        <p:spPr>
          <a:xfrm rot="18900000">
            <a:off x="3943163" y="3430854"/>
            <a:ext cx="485053" cy="4046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fere with my treatment</a:t>
            </a:r>
          </a:p>
        </p:txBody>
      </p:sp>
      <p:sp>
        <p:nvSpPr>
          <p:cNvPr id="119" name="tx118"/>
          <p:cNvSpPr/>
          <p:nvPr/>
        </p:nvSpPr>
        <p:spPr>
          <a:xfrm rot="18900000">
            <a:off x="4130829" y="3404197"/>
            <a:ext cx="305222" cy="3189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>
                <a:solidFill>
                  <a:srgbClr val="4D4D4D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other disease</a:t>
            </a:r>
          </a:p>
        </p:txBody>
      </p:sp>
      <p:sp>
        <p:nvSpPr>
          <p:cNvPr id="120" name="tx119"/>
          <p:cNvSpPr/>
          <p:nvPr/>
        </p:nvSpPr>
        <p:spPr>
          <a:xfrm>
            <a:off x="2242353" y="3837858"/>
            <a:ext cx="461062" cy="34503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68"/>
              </a:lnSpc>
            </a:pPr>
            <a:r>
              <a:rPr sz="468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adherence reason</a:t>
            </a:r>
          </a:p>
        </p:txBody>
      </p:sp>
      <p:sp>
        <p:nvSpPr>
          <p:cNvPr id="121" name="tx120"/>
          <p:cNvSpPr/>
          <p:nvPr/>
        </p:nvSpPr>
        <p:spPr>
          <a:xfrm rot="16200000">
            <a:off x="5676" y="2167188"/>
            <a:ext cx="126553" cy="3336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68"/>
              </a:lnSpc>
            </a:pPr>
            <a:r>
              <a:rPr sz="468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</a:p>
        </p:txBody>
      </p:sp>
      <p:sp>
        <p:nvSpPr>
          <p:cNvPr id="122" name="tx121"/>
          <p:cNvSpPr/>
          <p:nvPr/>
        </p:nvSpPr>
        <p:spPr>
          <a:xfrm>
            <a:off x="1427807" y="1039029"/>
            <a:ext cx="164010" cy="48554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507"/>
              </a:lnSpc>
            </a:pPr>
            <a:r>
              <a:rPr sz="507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ey</a:t>
            </a:r>
          </a:p>
        </p:txBody>
      </p:sp>
      <p:sp>
        <p:nvSpPr>
          <p:cNvPr id="123" name="rc122"/>
          <p:cNvSpPr/>
          <p:nvPr/>
        </p:nvSpPr>
        <p:spPr>
          <a:xfrm>
            <a:off x="1658071" y="1029109"/>
            <a:ext cx="64999" cy="68390"/>
          </a:xfrm>
          <a:prstGeom prst="rect">
            <a:avLst/>
          </a:prstGeom>
          <a:solidFill>
            <a:srgbClr val="4A6F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rc123"/>
          <p:cNvSpPr/>
          <p:nvPr/>
        </p:nvSpPr>
        <p:spPr>
          <a:xfrm>
            <a:off x="2144834" y="1029109"/>
            <a:ext cx="64999" cy="68390"/>
          </a:xfrm>
          <a:prstGeom prst="rect">
            <a:avLst/>
          </a:prstGeom>
          <a:solidFill>
            <a:srgbClr val="A3C1E3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rc124"/>
          <p:cNvSpPr/>
          <p:nvPr/>
        </p:nvSpPr>
        <p:spPr>
          <a:xfrm>
            <a:off x="2642983" y="1029109"/>
            <a:ext cx="64999" cy="68390"/>
          </a:xfrm>
          <a:prstGeom prst="rect">
            <a:avLst/>
          </a:prstGeom>
          <a:solidFill>
            <a:srgbClr val="E8AC6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rc125"/>
          <p:cNvSpPr/>
          <p:nvPr/>
        </p:nvSpPr>
        <p:spPr>
          <a:xfrm>
            <a:off x="3141132" y="1029109"/>
            <a:ext cx="64999" cy="68390"/>
          </a:xfrm>
          <a:prstGeom prst="rect">
            <a:avLst/>
          </a:prstGeom>
          <a:solidFill>
            <a:srgbClr val="A5A5A5">
              <a:alpha val="100000"/>
            </a:srgbClr>
          </a:solidFill>
        </p:spPr>
        <p:txBody>
          <a:bodyPr/>
          <a:lstStyle/>
          <a:p>
            <a:endParaRPr sz="137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x126"/>
          <p:cNvSpPr/>
          <p:nvPr/>
        </p:nvSpPr>
        <p:spPr>
          <a:xfrm>
            <a:off x="1789325" y="1043340"/>
            <a:ext cx="289255" cy="39935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line survey</a:t>
            </a:r>
          </a:p>
        </p:txBody>
      </p:sp>
      <p:sp>
        <p:nvSpPr>
          <p:cNvPr id="128" name="tx127"/>
          <p:cNvSpPr/>
          <p:nvPr/>
        </p:nvSpPr>
        <p:spPr>
          <a:xfrm>
            <a:off x="2276087" y="1037565"/>
            <a:ext cx="300641" cy="45719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month fo</a:t>
            </a:r>
            <a:r>
              <a:rPr lang="en-US" altLang="zh-CN"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lo</a:t>
            </a:r>
            <a:r>
              <a:rPr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-up</a:t>
            </a:r>
          </a:p>
        </p:txBody>
      </p:sp>
      <p:sp>
        <p:nvSpPr>
          <p:cNvPr id="129" name="tx128"/>
          <p:cNvSpPr/>
          <p:nvPr/>
        </p:nvSpPr>
        <p:spPr>
          <a:xfrm>
            <a:off x="2774237" y="1043328"/>
            <a:ext cx="300641" cy="399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month follow-up</a:t>
            </a:r>
          </a:p>
        </p:txBody>
      </p:sp>
      <p:sp>
        <p:nvSpPr>
          <p:cNvPr id="130" name="tx129"/>
          <p:cNvSpPr/>
          <p:nvPr/>
        </p:nvSpPr>
        <p:spPr>
          <a:xfrm>
            <a:off x="3272388" y="1043328"/>
            <a:ext cx="300641" cy="3995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422"/>
              </a:lnSpc>
            </a:pPr>
            <a:r>
              <a:rPr sz="422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month follow-up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129</Words>
  <Application>Microsoft Office PowerPoint</Application>
  <PresentationFormat>自定义</PresentationFormat>
  <Paragraphs>6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>李擎宇</dc:creator>
  <cp:keywords/>
  <dc:description/>
  <cp:lastModifiedBy>擎宇 李</cp:lastModifiedBy>
  <cp:revision>7</cp:revision>
  <dcterms:created xsi:type="dcterms:W3CDTF">2017-02-13T16:18:36Z</dcterms:created>
  <dcterms:modified xsi:type="dcterms:W3CDTF">2025-08-07T13:03:53Z</dcterms:modified>
  <cp:category/>
</cp:coreProperties>
</file>